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86AEDF"/>
    <a:srgbClr val="D2645E"/>
    <a:srgbClr val="919191"/>
    <a:srgbClr val="EFBE04"/>
    <a:srgbClr val="4D9E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C92C92-3E5B-4E80-87A4-9F823522CF6F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FA9154-48BA-4AC8-9255-E492BAB21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2980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FA9154-48BA-4AC8-9255-E492BAB2153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9153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000BA55E-549C-1434-12D2-FD11A88E89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="" xmlns:a16="http://schemas.microsoft.com/office/drawing/2014/main" id="{DC6089F8-1D2B-575E-6A31-42E3D14CD8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55FE2E95-4093-89F8-A276-57FC2409C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1B15F7F1-62BA-D9C6-AB89-C52CF7D47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CF666B4E-8731-0ACD-964C-258BA9FD9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811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581DD438-CA55-7555-FD65-6CEA8B1D9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2C7C9719-9264-CAC7-0441-928555BD93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15FE70D1-673E-5A03-E28C-BD4AF202A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E2D69D2E-BB61-F675-5A05-2A98DC9E7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C4292E00-CD37-3E32-5CE4-D2FCA7E4C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157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1C33CBAA-FBED-563A-EC6D-E0EB2E9196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E8AA7AF3-F3F7-A678-DBF5-1D863448DC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12D138E0-D40E-D43E-E480-4524034B2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1A467D59-3BDB-6B8C-9272-7E0DFCE9B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E6B43392-AC01-7715-233C-3C9355002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5733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A4B3AF2B-63A3-F5D2-37BC-DFA4813EF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2D2BEBD8-D992-167C-F23A-11042EB3C8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A01D684D-ACAC-680C-9BCE-6671E3BCC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69219FB0-92A5-2147-1C86-17E66E9F0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D6FFE0C5-B4BA-2C23-F3CB-C751E53FE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4095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A959ED28-0845-BCA1-1C08-AD76217C5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8D8AD9EA-FA4B-B1E0-1B66-92F20CB9DC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2B740475-08F8-7278-55A2-4C3FA0B93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06FB0F8F-DE72-A804-97CF-784594150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AFDE9E41-9567-9959-95F2-A43BAE832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1849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811EA79C-9A72-33F1-5444-B9610F39D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7EB69DC5-91F0-E73F-3C1F-C938158260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68189593-778A-FCC4-4D40-63926014BE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CD0A9199-AB25-E08B-6B63-DFB24BF83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E808B5CC-A25E-F229-AC27-43EAF776D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1C581575-9E58-0EA4-D5BC-EC98062A2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894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52493BA8-A5C5-8DE2-500F-825348A6F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1FDEC504-6E2E-F95A-43D3-34317AC98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5B7C86CB-A32C-0054-38E4-0DD02B8A7B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8F1D0AC3-FF9F-8822-22BB-FFA1DEA7CD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D414E02D-5F4F-A13E-5C62-E33F021186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19EFA593-6A7C-0F97-6EF3-608D34B11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EC3CBF13-486D-9F1D-AFD2-2531E5715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BEB1D0A7-370B-70ED-9FC0-2ECF68EEE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4919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0E2050DD-7DBC-0994-CD03-1239E876D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8FDF136D-090E-2C21-68ED-002219519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EC296325-BD62-EBE9-392D-7591E44AE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D07D422B-E7F5-CA85-C4EB-1BB8FC782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807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56322CB6-0EC1-FE68-80DD-1B7B31029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1FD7E45E-498B-E223-A94E-72000BBEE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B1BC6ADC-5D96-96DD-D088-785AAD992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489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B5D51AE4-989D-E2AA-EB1B-7678F8AF97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65E54F76-53F1-F7DC-69D7-9ED085993A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62515FE0-EB76-ADCD-864F-3BCC68C73F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AC37D0C1-FB05-42DD-9B25-19DFB4A15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0A133603-07E4-C326-B2F8-B5BD86D05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4880C0FD-372A-04EF-9D8E-EC9BFC2D8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2515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6762FCFD-377C-7D06-361E-1D8C1DF361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9DA1A130-1632-428D-1B66-0A8A96A00D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73E72691-59C4-F5F9-9B4C-634FDA18DA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175BAB6C-5AB1-C624-2C37-C6C2F344A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AD8A51BF-F029-43DC-A9E2-C26034B87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50DDB564-BE76-EDA8-ED31-B83591712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9181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359850C6-3328-623D-D4D7-6CE72C65FC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BE7B27D3-FC50-59CF-E52C-5C07DCB50D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6665F665-5916-6493-775C-D73F3A1E8E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89A47545-EC67-44B0-8625-A147428DB3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9D7D52DB-CDE2-A03F-B2BC-FA3A4506BA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393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E10B17F2-7545-B859-A67C-D77D9117F7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="" xmlns:a16="http://schemas.microsoft.com/office/drawing/2014/main" id="{AC15A417-4565-005A-EC16-08F8695D3F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7947" y="0"/>
            <a:ext cx="8229600" cy="6858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C44383B4-8B13-F0FD-07B8-C6574245DB43}"/>
              </a:ext>
            </a:extLst>
          </p:cNvPr>
          <p:cNvSpPr txBox="1"/>
          <p:nvPr/>
        </p:nvSpPr>
        <p:spPr>
          <a:xfrm>
            <a:off x="217714" y="1121229"/>
            <a:ext cx="2287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="" xmlns:a16="http://schemas.microsoft.com/office/drawing/2014/main" id="{EF8030CD-8DF1-1418-5213-CDA48C9336F5}"/>
              </a:ext>
            </a:extLst>
          </p:cNvPr>
          <p:cNvSpPr/>
          <p:nvPr/>
        </p:nvSpPr>
        <p:spPr>
          <a:xfrm>
            <a:off x="2225682" y="3379305"/>
            <a:ext cx="2246243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6" name="正方形/長方形 15">
            <a:extLst>
              <a:ext uri="{FF2B5EF4-FFF2-40B4-BE49-F238E27FC236}">
                <a16:creationId xmlns="" xmlns:a16="http://schemas.microsoft.com/office/drawing/2014/main" id="{985E98FE-7F9B-B170-70B3-C53F32B0611B}"/>
              </a:ext>
            </a:extLst>
          </p:cNvPr>
          <p:cNvSpPr/>
          <p:nvPr/>
        </p:nvSpPr>
        <p:spPr>
          <a:xfrm>
            <a:off x="2990994" y="272933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="" xmlns:a16="http://schemas.microsoft.com/office/drawing/2014/main" id="{52CFC6D1-89B2-FAFC-3DB6-0ACD250D9378}"/>
              </a:ext>
            </a:extLst>
          </p:cNvPr>
          <p:cNvSpPr/>
          <p:nvPr/>
        </p:nvSpPr>
        <p:spPr>
          <a:xfrm>
            <a:off x="2979609" y="893745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="" xmlns:a16="http://schemas.microsoft.com/office/drawing/2014/main" id="{030646D0-8C2F-42A8-189F-C320494B28F9}"/>
              </a:ext>
            </a:extLst>
          </p:cNvPr>
          <p:cNvSpPr/>
          <p:nvPr/>
        </p:nvSpPr>
        <p:spPr>
          <a:xfrm>
            <a:off x="2996100" y="1505964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="" xmlns:a16="http://schemas.microsoft.com/office/drawing/2014/main" id="{1ED7F778-CA01-8605-29A0-0FE40DD5EC1F}"/>
              </a:ext>
            </a:extLst>
          </p:cNvPr>
          <p:cNvSpPr/>
          <p:nvPr/>
        </p:nvSpPr>
        <p:spPr>
          <a:xfrm>
            <a:off x="2984715" y="2126776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="" xmlns:a16="http://schemas.microsoft.com/office/drawing/2014/main" id="{99B9B7CF-5168-9ECC-5F94-881F41685961}"/>
              </a:ext>
            </a:extLst>
          </p:cNvPr>
          <p:cNvSpPr/>
          <p:nvPr/>
        </p:nvSpPr>
        <p:spPr>
          <a:xfrm>
            <a:off x="2985888" y="2742329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="" xmlns:a16="http://schemas.microsoft.com/office/drawing/2014/main" id="{D688C084-8E31-5EA4-42CC-6AF69F6BC596}"/>
              </a:ext>
            </a:extLst>
          </p:cNvPr>
          <p:cNvSpPr/>
          <p:nvPr/>
        </p:nvSpPr>
        <p:spPr>
          <a:xfrm>
            <a:off x="3002379" y="3354548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="" xmlns:a16="http://schemas.microsoft.com/office/drawing/2014/main" id="{855854F1-5882-D87E-DBAD-F3E0CB91CC24}"/>
              </a:ext>
            </a:extLst>
          </p:cNvPr>
          <p:cNvSpPr/>
          <p:nvPr/>
        </p:nvSpPr>
        <p:spPr>
          <a:xfrm>
            <a:off x="2990994" y="3975360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="" xmlns:a16="http://schemas.microsoft.com/office/drawing/2014/main" id="{B6AE8FE8-52E4-E6BE-228E-9F1285BD30FB}"/>
              </a:ext>
            </a:extLst>
          </p:cNvPr>
          <p:cNvSpPr/>
          <p:nvPr/>
        </p:nvSpPr>
        <p:spPr>
          <a:xfrm>
            <a:off x="2983522" y="4646621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="" xmlns:a16="http://schemas.microsoft.com/office/drawing/2014/main" id="{DBD92282-47A1-5181-5189-9B1421FE96E9}"/>
              </a:ext>
            </a:extLst>
          </p:cNvPr>
          <p:cNvSpPr/>
          <p:nvPr/>
        </p:nvSpPr>
        <p:spPr>
          <a:xfrm>
            <a:off x="3000013" y="5258840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>
            <a:extLst>
              <a:ext uri="{FF2B5EF4-FFF2-40B4-BE49-F238E27FC236}">
                <a16:creationId xmlns="" xmlns:a16="http://schemas.microsoft.com/office/drawing/2014/main" id="{B50C7299-4829-E108-FF00-D6668AC16DFC}"/>
              </a:ext>
            </a:extLst>
          </p:cNvPr>
          <p:cNvSpPr/>
          <p:nvPr/>
        </p:nvSpPr>
        <p:spPr>
          <a:xfrm>
            <a:off x="2988628" y="5879652"/>
            <a:ext cx="148093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="" xmlns:a16="http://schemas.microsoft.com/office/drawing/2014/main" id="{5A7FE66B-3425-95E6-A046-97503E7682F4}"/>
              </a:ext>
            </a:extLst>
          </p:cNvPr>
          <p:cNvSpPr txBox="1"/>
          <p:nvPr/>
        </p:nvSpPr>
        <p:spPr>
          <a:xfrm>
            <a:off x="1861929" y="281512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tage IV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="" xmlns:a16="http://schemas.microsoft.com/office/drawing/2014/main" id="{53DAAFE4-B50D-67DB-1E52-715FBDC6E44F}"/>
              </a:ext>
            </a:extLst>
          </p:cNvPr>
          <p:cNvSpPr txBox="1"/>
          <p:nvPr/>
        </p:nvSpPr>
        <p:spPr>
          <a:xfrm>
            <a:off x="1861929" y="921102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tage III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="" xmlns:a16="http://schemas.microsoft.com/office/drawing/2014/main" id="{D8A1B82C-1181-A82E-5B30-A9D2D04DED13}"/>
              </a:ext>
            </a:extLst>
          </p:cNvPr>
          <p:cNvSpPr txBox="1"/>
          <p:nvPr/>
        </p:nvSpPr>
        <p:spPr>
          <a:xfrm>
            <a:off x="1861929" y="1536799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COG PS of 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="" xmlns:a16="http://schemas.microsoft.com/office/drawing/2014/main" id="{69DF8C11-FA5B-89B5-E68C-70A2A91A8ECD}"/>
              </a:ext>
            </a:extLst>
          </p:cNvPr>
          <p:cNvSpPr txBox="1"/>
          <p:nvPr/>
        </p:nvSpPr>
        <p:spPr>
          <a:xfrm>
            <a:off x="1872727" y="2154752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COG PS of 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="" xmlns:a16="http://schemas.microsoft.com/office/drawing/2014/main" id="{2CC87CF1-6358-9494-B376-EDCFCD9743C4}"/>
              </a:ext>
            </a:extLst>
          </p:cNvPr>
          <p:cNvSpPr txBox="1"/>
          <p:nvPr/>
        </p:nvSpPr>
        <p:spPr>
          <a:xfrm>
            <a:off x="1872727" y="2756129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-8 scor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="" xmlns:a16="http://schemas.microsoft.com/office/drawing/2014/main" id="{F2D7B4AA-4C71-8B67-56FA-F0EC61953D0C}"/>
              </a:ext>
            </a:extLst>
          </p:cNvPr>
          <p:cNvSpPr txBox="1"/>
          <p:nvPr/>
        </p:nvSpPr>
        <p:spPr>
          <a:xfrm>
            <a:off x="1908549" y="5283365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 19-9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="" xmlns:a16="http://schemas.microsoft.com/office/drawing/2014/main" id="{1A70B16B-3000-4C47-1284-6CD893700833}"/>
              </a:ext>
            </a:extLst>
          </p:cNvPr>
          <p:cNvSpPr txBox="1"/>
          <p:nvPr/>
        </p:nvSpPr>
        <p:spPr>
          <a:xfrm>
            <a:off x="1872727" y="4019056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="" xmlns:a16="http://schemas.microsoft.com/office/drawing/2014/main" id="{A43FFECE-020E-683A-6A8F-3C08E87BF631}"/>
              </a:ext>
            </a:extLst>
          </p:cNvPr>
          <p:cNvSpPr txBox="1"/>
          <p:nvPr/>
        </p:nvSpPr>
        <p:spPr>
          <a:xfrm>
            <a:off x="1908549" y="4637008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RP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96A9B332-E8FD-7DC4-7E5C-13AD13878AF5}"/>
              </a:ext>
            </a:extLst>
          </p:cNvPr>
          <p:cNvSpPr txBox="1"/>
          <p:nvPr/>
        </p:nvSpPr>
        <p:spPr>
          <a:xfrm>
            <a:off x="1892221" y="3401104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imary sit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an GB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3A6CACF5-6D4A-DA02-CF36-EF15DC1BE376}"/>
              </a:ext>
            </a:extLst>
          </p:cNvPr>
          <p:cNvSpPr txBox="1"/>
          <p:nvPr/>
        </p:nvSpPr>
        <p:spPr>
          <a:xfrm>
            <a:off x="1892721" y="5896915"/>
            <a:ext cx="2653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3781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</TotalTime>
  <Words>29</Words>
  <Application>Microsoft Office PowerPoint</Application>
  <PresentationFormat>Widescreen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oshi kobayashi</dc:creator>
  <cp:lastModifiedBy>Dhivya Kathirvel</cp:lastModifiedBy>
  <cp:revision>10</cp:revision>
  <dcterms:created xsi:type="dcterms:W3CDTF">2025-02-11T13:41:18Z</dcterms:created>
  <dcterms:modified xsi:type="dcterms:W3CDTF">2025-08-29T14:12:22Z</dcterms:modified>
</cp:coreProperties>
</file>